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69696"/>
    <a:srgbClr val="C0C0C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9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012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01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200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9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614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47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232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18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42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1326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238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B368E-2406-43BF-91B4-17583E779D59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EF55C-1F6D-47C0-A953-67CE51908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602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Group 3">
            <a:extLst>
              <a:ext uri="{FF2B5EF4-FFF2-40B4-BE49-F238E27FC236}">
                <a16:creationId xmlns:a16="http://schemas.microsoft.com/office/drawing/2014/main" id="{21452061-6ACC-4A06-8DA7-272F18BAE3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1850463"/>
              </p:ext>
            </p:extLst>
          </p:nvPr>
        </p:nvGraphicFramePr>
        <p:xfrm>
          <a:off x="406670" y="632596"/>
          <a:ext cx="6766289" cy="6056158"/>
        </p:xfrm>
        <a:graphic>
          <a:graphicData uri="http://schemas.openxmlformats.org/drawingml/2006/table">
            <a:tbl>
              <a:tblPr/>
              <a:tblGrid>
                <a:gridCol w="162985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681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029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097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664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2505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2097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3664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2505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551076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2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eason's</a:t>
                      </a: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 Product-moment correlation (PPMC)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2552" marR="92552" marT="46276" marB="4627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pearman's rank difference correlation (SRDC)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2552" marR="92552" marT="46276" marB="4627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1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Variation 2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n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ｒ</a:t>
                      </a:r>
                      <a:endParaRPr kumimoji="1" lang="ja-JP" altLang="en-US" sz="17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2552" marR="92552" marT="46276" marB="4627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ρ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 valu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2552" marR="92552" marT="46276" marB="46276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73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0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78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3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umor  volume %chang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5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8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8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9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8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0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4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8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0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5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0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2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2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2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9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1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2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3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8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2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2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8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9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7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2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1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0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8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03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0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0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1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4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6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5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4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7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48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2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FS (days)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98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5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01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0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3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26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8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97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77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4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63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2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77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3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7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CD26  Day29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53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1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3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7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 1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918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4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259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320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32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19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525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15  Post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61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54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06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83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re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446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150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525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82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　</a:t>
                      </a:r>
                      <a:endParaRPr kumimoji="1" lang="ja-JP" altLang="en-US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5023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〃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PP4  Day29  Post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2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29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26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0.624 </a:t>
                      </a:r>
                      <a:endParaRPr kumimoji="1" lang="en-US" altLang="ja-JP" sz="17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38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*</a:t>
                      </a:r>
                      <a:endParaRPr kumimoji="1" lang="en-US" altLang="ja-JP" sz="17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88316" marR="88316" marT="44158" marB="44158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FC2032B-5D2D-40B0-9A09-80B3C508B4E3}"/>
              </a:ext>
            </a:extLst>
          </p:cNvPr>
          <p:cNvSpPr txBox="1"/>
          <p:nvPr/>
        </p:nvSpPr>
        <p:spPr>
          <a:xfrm>
            <a:off x="301801" y="12962"/>
            <a:ext cx="6688241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6. Correlation between serum sCD26/DPP4 titer variation (%) and tumor volume </a:t>
            </a:r>
          </a:p>
          <a:p>
            <a:r>
              <a:rPr kumimoji="1"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 or PFS (days) in 12 MM cases with Q2W administration by PPMC or SRDC analysis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5221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8</TotalTime>
  <Words>324</Words>
  <Application>Microsoft Office PowerPoint</Application>
  <PresentationFormat>画面に合わせる (4:3)</PresentationFormat>
  <Paragraphs>2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n</dc:creator>
  <cp:lastModifiedBy> </cp:lastModifiedBy>
  <cp:revision>51</cp:revision>
  <cp:lastPrinted>2020-10-09T00:45:33Z</cp:lastPrinted>
  <dcterms:created xsi:type="dcterms:W3CDTF">2020-04-13T08:26:21Z</dcterms:created>
  <dcterms:modified xsi:type="dcterms:W3CDTF">2020-12-08T18:17:16Z</dcterms:modified>
</cp:coreProperties>
</file>